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drawings/drawing3.xml" ContentType="application/vnd.openxmlformats-officedocument.drawingml.chartshapes+xml"/>
  <Override PartName="/ppt/drawings/drawing4.xml" ContentType="application/vnd.openxmlformats-officedocument.drawingml.chartshapes+xml"/>
  <Override PartName="/ppt/charts/style1.xml" ContentType="application/vnd.ms-office.chartstyl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drawings/drawing1.xml" ContentType="application/vnd.openxmlformats-officedocument.drawingml.chartshapes+xml"/>
  <Override PartName="/ppt/drawings/drawing2.xml" ContentType="application/vnd.openxmlformats-officedocument.drawingml.chartshape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harts/colors1.xml" ContentType="application/vnd.ms-office.chartcolorstyle+xml"/>
  <Override PartName="/ppt/slideLayouts/slideLayout10.xml" ContentType="application/vnd.openxmlformats-officedocument.presentationml.slideLayout+xml"/>
  <Override PartName="/ppt/charts/chart3.xml" ContentType="application/vnd.openxmlformats-officedocument.drawingml.chart+xml"/>
  <Override PartName="/ppt/charts/chart4.xml" ContentType="application/vnd.openxmlformats-officedocument.drawingml.chart+xml"/>
  <Default Extension="xlsx" ContentType="application/vnd.openxmlformats-officedocument.spreadsheetml.sheet"/>
  <Override PartName="/ppt/charts/chart5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pl-P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20" d="100"/>
          <a:sy n="120" d="100"/>
        </p:scale>
        <p:origin x="-228" y="-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CB_USER\Desktop\Projekty,%20wyniki\D.glomerata\D.%20glomerata%20fluorescencja\Pr&#243;ba4_26.10.2012\dane_xls\Wyniki%202.xls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C:\Users\MCB_USER\Desktop\Projekty,%20wyniki\D.glomerata\D.%20glomerata%20fluorescencja\Pr&#243;ba4_26.10.2012\dane_xls\Wyniki%202.xls" TargetMode="Externa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.xml"/><Relationship Id="rId1" Type="http://schemas.openxmlformats.org/officeDocument/2006/relationships/oleObject" Target="file:///C:\Users\MCB_USER\Desktop\Projekty,%20wyniki\D.glomerata\D.%20glomerata%20fluorescencja\Pr&#243;ba4_26.10.2012\dane_xls\Wyniki%202.xls" TargetMode="Externa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3.xml"/><Relationship Id="rId1" Type="http://schemas.openxmlformats.org/officeDocument/2006/relationships/package" Target="../embeddings/Arkusz_programu_Microsoft_Office_Excel1.xlsx"/></Relationships>
</file>

<file path=ppt/charts/_rels/chart5.xml.rels><?xml version="1.0" encoding="UTF-8" standalone="yes"?>
<Relationships xmlns="http://schemas.openxmlformats.org/package/2006/relationships"><Relationship Id="rId3" Type="http://schemas.microsoft.com/office/2011/relationships/chartColorStyle" Target="colors1.xml"/><Relationship Id="rId2" Type="http://schemas.openxmlformats.org/officeDocument/2006/relationships/chartUserShapes" Target="../drawings/drawing4.xml"/><Relationship Id="rId1" Type="http://schemas.openxmlformats.org/officeDocument/2006/relationships/package" Target="../embeddings/Arkusz_programu_Microsoft_Office_Excel2.xlsx"/><Relationship Id="rId4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pl-PL"/>
  <c:chart>
    <c:plotArea>
      <c:layout>
        <c:manualLayout>
          <c:layoutTarget val="inner"/>
          <c:xMode val="edge"/>
          <c:yMode val="edge"/>
          <c:x val="0.14102904040404041"/>
          <c:y val="3.5880555555555561E-2"/>
          <c:w val="0.83406605424321967"/>
          <c:h val="0.75296660834062412"/>
        </c:manualLayout>
      </c:layout>
      <c:lineChart>
        <c:grouping val="standard"/>
        <c:ser>
          <c:idx val="0"/>
          <c:order val="0"/>
          <c:tx>
            <c:v>control</c:v>
          </c:tx>
          <c:spPr>
            <a:ln>
              <a:solidFill>
                <a:schemeClr val="bg1">
                  <a:lumMod val="65000"/>
                </a:schemeClr>
              </a:solidFill>
            </a:ln>
          </c:spPr>
          <c:marker>
            <c:spPr>
              <a:solidFill>
                <a:schemeClr val="bg1">
                  <a:lumMod val="65000"/>
                </a:schemeClr>
              </a:solidFill>
            </c:spPr>
          </c:marker>
          <c:val>
            <c:numRef>
              <c:f>PSII!$K$3:$K$28</c:f>
              <c:numCache>
                <c:formatCode>General</c:formatCode>
                <c:ptCount val="26"/>
                <c:pt idx="0">
                  <c:v>0.80137500000000017</c:v>
                </c:pt>
                <c:pt idx="1">
                  <c:v>0.71312500000000012</c:v>
                </c:pt>
                <c:pt idx="2">
                  <c:v>9.0125000000000052E-2</c:v>
                </c:pt>
                <c:pt idx="3">
                  <c:v>0.24612500000000001</c:v>
                </c:pt>
                <c:pt idx="4">
                  <c:v>0.25375000000000003</c:v>
                </c:pt>
                <c:pt idx="5">
                  <c:v>0.26637500000000008</c:v>
                </c:pt>
                <c:pt idx="6">
                  <c:v>0.28987500000000016</c:v>
                </c:pt>
                <c:pt idx="7">
                  <c:v>0.31862500000000016</c:v>
                </c:pt>
                <c:pt idx="8">
                  <c:v>0.34250000000000014</c:v>
                </c:pt>
                <c:pt idx="9">
                  <c:v>0.36162500000000009</c:v>
                </c:pt>
                <c:pt idx="10">
                  <c:v>0.37325000000000008</c:v>
                </c:pt>
                <c:pt idx="11">
                  <c:v>0.38050000000000006</c:v>
                </c:pt>
                <c:pt idx="12">
                  <c:v>0.38937500000000014</c:v>
                </c:pt>
                <c:pt idx="13">
                  <c:v>0.39850000000000008</c:v>
                </c:pt>
                <c:pt idx="14">
                  <c:v>0.40500000000000003</c:v>
                </c:pt>
                <c:pt idx="15">
                  <c:v>0.41249999999999998</c:v>
                </c:pt>
                <c:pt idx="16">
                  <c:v>0.41837500000000005</c:v>
                </c:pt>
                <c:pt idx="17">
                  <c:v>0.42587500000000006</c:v>
                </c:pt>
                <c:pt idx="18">
                  <c:v>0.4290000000000001</c:v>
                </c:pt>
                <c:pt idx="19">
                  <c:v>0.4351250000000001</c:v>
                </c:pt>
                <c:pt idx="20">
                  <c:v>0.44025000000000009</c:v>
                </c:pt>
                <c:pt idx="21">
                  <c:v>0.44412500000000016</c:v>
                </c:pt>
                <c:pt idx="22">
                  <c:v>0.44712500000000016</c:v>
                </c:pt>
                <c:pt idx="23">
                  <c:v>0.45325000000000004</c:v>
                </c:pt>
                <c:pt idx="24">
                  <c:v>0.45787500000000009</c:v>
                </c:pt>
                <c:pt idx="25">
                  <c:v>0.45975000000000005</c:v>
                </c:pt>
              </c:numCache>
            </c:numRef>
          </c:val>
        </c:ser>
        <c:ser>
          <c:idx val="1"/>
          <c:order val="1"/>
          <c:tx>
            <c:v>endophyte</c:v>
          </c:tx>
          <c:spPr>
            <a:ln>
              <a:solidFill>
                <a:schemeClr val="tx1"/>
              </a:solidFill>
            </a:ln>
          </c:spPr>
          <c:marker>
            <c:spPr>
              <a:solidFill>
                <a:schemeClr val="tx1"/>
              </a:solidFill>
            </c:spPr>
          </c:marker>
          <c:val>
            <c:numRef>
              <c:f>PSII!$Y$3:$Y$28</c:f>
              <c:numCache>
                <c:formatCode>General</c:formatCode>
                <c:ptCount val="26"/>
                <c:pt idx="0">
                  <c:v>0.81022222222222229</c:v>
                </c:pt>
                <c:pt idx="1">
                  <c:v>0.73655555555555563</c:v>
                </c:pt>
                <c:pt idx="2">
                  <c:v>8.6888888888888904E-2</c:v>
                </c:pt>
                <c:pt idx="3">
                  <c:v>0.30244444444444452</c:v>
                </c:pt>
                <c:pt idx="4">
                  <c:v>0.32522222222222236</c:v>
                </c:pt>
                <c:pt idx="5">
                  <c:v>0.33666666666666678</c:v>
                </c:pt>
                <c:pt idx="6">
                  <c:v>0.35255555555555551</c:v>
                </c:pt>
                <c:pt idx="7">
                  <c:v>0.37233333333333335</c:v>
                </c:pt>
                <c:pt idx="8">
                  <c:v>0.39144444444444454</c:v>
                </c:pt>
                <c:pt idx="9">
                  <c:v>0.40522222222222226</c:v>
                </c:pt>
                <c:pt idx="10">
                  <c:v>0.41600000000000009</c:v>
                </c:pt>
                <c:pt idx="11">
                  <c:v>0.42511111111111105</c:v>
                </c:pt>
                <c:pt idx="12">
                  <c:v>0.4328888888888891</c:v>
                </c:pt>
                <c:pt idx="13">
                  <c:v>0.4383333333333333</c:v>
                </c:pt>
                <c:pt idx="14">
                  <c:v>0.44588888888888906</c:v>
                </c:pt>
                <c:pt idx="15">
                  <c:v>0.4502222222222223</c:v>
                </c:pt>
                <c:pt idx="16">
                  <c:v>0.4545555555555556</c:v>
                </c:pt>
                <c:pt idx="17">
                  <c:v>0.45933333333333326</c:v>
                </c:pt>
                <c:pt idx="18">
                  <c:v>0.46344444444444455</c:v>
                </c:pt>
                <c:pt idx="19">
                  <c:v>0.46755555555555556</c:v>
                </c:pt>
                <c:pt idx="20">
                  <c:v>0.47111111111111115</c:v>
                </c:pt>
                <c:pt idx="21">
                  <c:v>0.47477777777777785</c:v>
                </c:pt>
                <c:pt idx="22">
                  <c:v>0.47744444444444445</c:v>
                </c:pt>
                <c:pt idx="23">
                  <c:v>0.47877777777777786</c:v>
                </c:pt>
                <c:pt idx="24">
                  <c:v>0.4816666666666668</c:v>
                </c:pt>
                <c:pt idx="25">
                  <c:v>0.48411111111111105</c:v>
                </c:pt>
              </c:numCache>
            </c:numRef>
          </c:val>
        </c:ser>
        <c:dLbls/>
        <c:marker val="1"/>
        <c:axId val="45288064"/>
        <c:axId val="46138112"/>
      </c:lineChart>
      <c:catAx>
        <c:axId val="45288064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pulse</a:t>
                </a:r>
              </a:p>
            </c:rich>
          </c:tx>
          <c:layout>
            <c:manualLayout>
              <c:xMode val="edge"/>
              <c:yMode val="edge"/>
              <c:x val="0.51538954505686785"/>
              <c:y val="0.90182852143482062"/>
            </c:manualLayout>
          </c:layout>
        </c:title>
        <c:numFmt formatCode="General" sourceLinked="1"/>
        <c:tickLblPos val="nextTo"/>
        <c:crossAx val="46138112"/>
        <c:crosses val="autoZero"/>
        <c:auto val="1"/>
        <c:lblAlgn val="ctr"/>
        <c:lblOffset val="100"/>
      </c:catAx>
      <c:valAx>
        <c:axId val="46138112"/>
        <c:scaling>
          <c:orientation val="minMax"/>
        </c:scaling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Y(II)</a:t>
                </a:r>
              </a:p>
            </c:rich>
          </c:tx>
          <c:layout>
            <c:manualLayout>
              <c:xMode val="edge"/>
              <c:yMode val="edge"/>
              <c:x val="1.1111111111111117E-2"/>
              <c:y val="0.35669145523476237"/>
            </c:manualLayout>
          </c:layout>
        </c:title>
        <c:numFmt formatCode="General" sourceLinked="1"/>
        <c:tickLblPos val="nextTo"/>
        <c:crossAx val="45288064"/>
        <c:crosses val="autoZero"/>
        <c:crossBetween val="between"/>
      </c:valAx>
    </c:plotArea>
    <c:plotVisOnly val="1"/>
    <c:dispBlanksAs val="gap"/>
  </c:chart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pl-PL"/>
  <c:chart>
    <c:plotArea>
      <c:layout>
        <c:manualLayout>
          <c:layoutTarget val="inner"/>
          <c:xMode val="edge"/>
          <c:yMode val="edge"/>
          <c:x val="8.8655074365704301E-2"/>
          <c:y val="5.1400554097404488E-2"/>
          <c:w val="0.86934405074365717"/>
          <c:h val="0.78169364246135908"/>
        </c:manualLayout>
      </c:layout>
      <c:lineChart>
        <c:grouping val="standard"/>
        <c:ser>
          <c:idx val="0"/>
          <c:order val="0"/>
          <c:tx>
            <c:v>control</c:v>
          </c:tx>
          <c:spPr>
            <a:ln>
              <a:solidFill>
                <a:schemeClr val="bg1">
                  <a:lumMod val="65000"/>
                </a:schemeClr>
              </a:solidFill>
            </a:ln>
          </c:spPr>
          <c:marker>
            <c:spPr>
              <a:solidFill>
                <a:schemeClr val="bg1">
                  <a:lumMod val="65000"/>
                </a:schemeClr>
              </a:solidFill>
            </c:spPr>
          </c:marker>
          <c:val>
            <c:numRef>
              <c:f>PSII!$K$31:$K$56</c:f>
              <c:numCache>
                <c:formatCode>General</c:formatCode>
                <c:ptCount val="26"/>
                <c:pt idx="0">
                  <c:v>0</c:v>
                </c:pt>
                <c:pt idx="1">
                  <c:v>0</c:v>
                </c:pt>
                <c:pt idx="2">
                  <c:v>2.3624999999999994</c:v>
                </c:pt>
                <c:pt idx="3">
                  <c:v>6.5374999999999996</c:v>
                </c:pt>
                <c:pt idx="4">
                  <c:v>6.7124999999999995</c:v>
                </c:pt>
                <c:pt idx="5">
                  <c:v>7.0374999999999996</c:v>
                </c:pt>
                <c:pt idx="6">
                  <c:v>7.6750000000000007</c:v>
                </c:pt>
                <c:pt idx="7">
                  <c:v>8.4375</c:v>
                </c:pt>
                <c:pt idx="8">
                  <c:v>9.0625000000000036</c:v>
                </c:pt>
                <c:pt idx="9">
                  <c:v>9.5749999999999993</c:v>
                </c:pt>
                <c:pt idx="10">
                  <c:v>9.8750000000000018</c:v>
                </c:pt>
                <c:pt idx="11">
                  <c:v>10.062500000000002</c:v>
                </c:pt>
                <c:pt idx="12">
                  <c:v>10.3</c:v>
                </c:pt>
                <c:pt idx="13">
                  <c:v>10.55</c:v>
                </c:pt>
                <c:pt idx="14">
                  <c:v>10.725</c:v>
                </c:pt>
                <c:pt idx="15">
                  <c:v>10.887500000000003</c:v>
                </c:pt>
                <c:pt idx="16">
                  <c:v>11.062500000000002</c:v>
                </c:pt>
                <c:pt idx="17">
                  <c:v>11.275</c:v>
                </c:pt>
                <c:pt idx="18">
                  <c:v>11.362500000000004</c:v>
                </c:pt>
                <c:pt idx="19">
                  <c:v>11.512500000000003</c:v>
                </c:pt>
                <c:pt idx="20">
                  <c:v>11.662500000000003</c:v>
                </c:pt>
                <c:pt idx="21">
                  <c:v>11.75</c:v>
                </c:pt>
                <c:pt idx="22">
                  <c:v>11.8375</c:v>
                </c:pt>
                <c:pt idx="23">
                  <c:v>12.012500000000003</c:v>
                </c:pt>
                <c:pt idx="24">
                  <c:v>12.112500000000002</c:v>
                </c:pt>
                <c:pt idx="25">
                  <c:v>12.1875</c:v>
                </c:pt>
              </c:numCache>
            </c:numRef>
          </c:val>
        </c:ser>
        <c:ser>
          <c:idx val="1"/>
          <c:order val="1"/>
          <c:tx>
            <c:v>endophyte</c:v>
          </c:tx>
          <c:spPr>
            <a:ln>
              <a:solidFill>
                <a:schemeClr val="tx1"/>
              </a:solidFill>
            </a:ln>
          </c:spPr>
          <c:marker>
            <c:spPr>
              <a:solidFill>
                <a:schemeClr val="tx1"/>
              </a:solidFill>
            </c:spPr>
          </c:marker>
          <c:val>
            <c:numRef>
              <c:f>PSII!$Y$31:$Y$56</c:f>
              <c:numCache>
                <c:formatCode>General</c:formatCode>
                <c:ptCount val="26"/>
                <c:pt idx="0">
                  <c:v>0</c:v>
                </c:pt>
                <c:pt idx="1">
                  <c:v>0</c:v>
                </c:pt>
                <c:pt idx="2">
                  <c:v>2.3000000000000003</c:v>
                </c:pt>
                <c:pt idx="3">
                  <c:v>8.0111111111111093</c:v>
                </c:pt>
                <c:pt idx="4">
                  <c:v>8.6</c:v>
                </c:pt>
                <c:pt idx="5">
                  <c:v>8.9000000000000021</c:v>
                </c:pt>
                <c:pt idx="6">
                  <c:v>9.3333333333333357</c:v>
                </c:pt>
                <c:pt idx="7">
                  <c:v>9.8333333333333357</c:v>
                </c:pt>
                <c:pt idx="8">
                  <c:v>10.366666666666671</c:v>
                </c:pt>
                <c:pt idx="9">
                  <c:v>10.711111111111109</c:v>
                </c:pt>
                <c:pt idx="10">
                  <c:v>11.011111111111106</c:v>
                </c:pt>
                <c:pt idx="11">
                  <c:v>11.233333333333333</c:v>
                </c:pt>
                <c:pt idx="12">
                  <c:v>11.455555555555557</c:v>
                </c:pt>
                <c:pt idx="13">
                  <c:v>11.6</c:v>
                </c:pt>
                <c:pt idx="14">
                  <c:v>11.78888888888889</c:v>
                </c:pt>
                <c:pt idx="15">
                  <c:v>11.900000000000002</c:v>
                </c:pt>
                <c:pt idx="16">
                  <c:v>12.022222222222222</c:v>
                </c:pt>
                <c:pt idx="17">
                  <c:v>12.133333333333333</c:v>
                </c:pt>
                <c:pt idx="18">
                  <c:v>12.266666666666667</c:v>
                </c:pt>
                <c:pt idx="19">
                  <c:v>12.344444444444447</c:v>
                </c:pt>
                <c:pt idx="20">
                  <c:v>12.466666666666669</c:v>
                </c:pt>
                <c:pt idx="21">
                  <c:v>12.555555555555559</c:v>
                </c:pt>
                <c:pt idx="22">
                  <c:v>12.633333333333333</c:v>
                </c:pt>
                <c:pt idx="23">
                  <c:v>12.677777777777777</c:v>
                </c:pt>
                <c:pt idx="24">
                  <c:v>12.733333333333333</c:v>
                </c:pt>
                <c:pt idx="25">
                  <c:v>12.822222222222223</c:v>
                </c:pt>
              </c:numCache>
            </c:numRef>
          </c:val>
        </c:ser>
        <c:dLbls/>
        <c:marker val="1"/>
        <c:axId val="46167552"/>
        <c:axId val="46169472"/>
      </c:lineChart>
      <c:catAx>
        <c:axId val="46167552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pulse</a:t>
                </a:r>
              </a:p>
            </c:rich>
          </c:tx>
          <c:layout/>
        </c:title>
        <c:numFmt formatCode="General" sourceLinked="1"/>
        <c:tickLblPos val="nextTo"/>
        <c:crossAx val="46169472"/>
        <c:crosses val="autoZero"/>
        <c:auto val="1"/>
        <c:lblAlgn val="ctr"/>
        <c:lblOffset val="100"/>
      </c:catAx>
      <c:valAx>
        <c:axId val="46169472"/>
        <c:scaling>
          <c:orientation val="minMax"/>
        </c:scaling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ETR</a:t>
                </a:r>
              </a:p>
            </c:rich>
          </c:tx>
          <c:layout/>
        </c:title>
        <c:numFmt formatCode="General" sourceLinked="1"/>
        <c:tickLblPos val="nextTo"/>
        <c:crossAx val="46167552"/>
        <c:crosses val="autoZero"/>
        <c:crossBetween val="between"/>
      </c:valAx>
    </c:plotArea>
    <c:plotVisOnly val="1"/>
    <c:dispBlanksAs val="gap"/>
  </c:chart>
  <c:externalData r:id="rId1"/>
  <c:userShapes r:id="rId2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pl-PL"/>
  <c:chart>
    <c:plotArea>
      <c:layout>
        <c:manualLayout>
          <c:layoutTarget val="inner"/>
          <c:xMode val="edge"/>
          <c:yMode val="edge"/>
          <c:x val="0.10947462817147859"/>
          <c:y val="5.1400554097404488E-2"/>
          <c:w val="0.87262073490813674"/>
          <c:h val="0.79095290172061827"/>
        </c:manualLayout>
      </c:layout>
      <c:lineChart>
        <c:grouping val="standard"/>
        <c:ser>
          <c:idx val="0"/>
          <c:order val="0"/>
          <c:tx>
            <c:v>control</c:v>
          </c:tx>
          <c:spPr>
            <a:ln>
              <a:solidFill>
                <a:schemeClr val="bg1">
                  <a:lumMod val="65000"/>
                </a:schemeClr>
              </a:solidFill>
            </a:ln>
          </c:spPr>
          <c:marker>
            <c:spPr>
              <a:solidFill>
                <a:schemeClr val="bg1">
                  <a:lumMod val="65000"/>
                </a:schemeClr>
              </a:solidFill>
            </c:spPr>
          </c:marker>
          <c:val>
            <c:numRef>
              <c:f>PSII!$K$59:$K$84</c:f>
              <c:numCache>
                <c:formatCode>General</c:formatCode>
                <c:ptCount val="26"/>
                <c:pt idx="0">
                  <c:v>0.20050000000000001</c:v>
                </c:pt>
                <c:pt idx="1">
                  <c:v>0.28100000000000008</c:v>
                </c:pt>
                <c:pt idx="2">
                  <c:v>0.89537500000000003</c:v>
                </c:pt>
                <c:pt idx="3">
                  <c:v>0.41737500000000005</c:v>
                </c:pt>
                <c:pt idx="4">
                  <c:v>0.31262500000000015</c:v>
                </c:pt>
                <c:pt idx="5">
                  <c:v>0.28000000000000003</c:v>
                </c:pt>
                <c:pt idx="6">
                  <c:v>0.263125</c:v>
                </c:pt>
                <c:pt idx="7">
                  <c:v>0.25474999999999998</c:v>
                </c:pt>
                <c:pt idx="8">
                  <c:v>0.2525</c:v>
                </c:pt>
                <c:pt idx="9">
                  <c:v>0.2511250000000001</c:v>
                </c:pt>
                <c:pt idx="10">
                  <c:v>0.25200000000000006</c:v>
                </c:pt>
                <c:pt idx="11">
                  <c:v>0.25237500000000002</c:v>
                </c:pt>
                <c:pt idx="12">
                  <c:v>0.25025000000000003</c:v>
                </c:pt>
                <c:pt idx="13">
                  <c:v>0.24825000000000003</c:v>
                </c:pt>
                <c:pt idx="14">
                  <c:v>0.24812500000000001</c:v>
                </c:pt>
                <c:pt idx="15">
                  <c:v>0.24750000000000003</c:v>
                </c:pt>
                <c:pt idx="16">
                  <c:v>0.24750000000000005</c:v>
                </c:pt>
                <c:pt idx="17">
                  <c:v>0.24625000000000002</c:v>
                </c:pt>
                <c:pt idx="18">
                  <c:v>0.24775000000000003</c:v>
                </c:pt>
                <c:pt idx="19">
                  <c:v>0.24625000000000002</c:v>
                </c:pt>
                <c:pt idx="20">
                  <c:v>0.24587499999999998</c:v>
                </c:pt>
                <c:pt idx="21">
                  <c:v>0.24662499999999998</c:v>
                </c:pt>
                <c:pt idx="22">
                  <c:v>0.24762499999999998</c:v>
                </c:pt>
                <c:pt idx="23">
                  <c:v>0.24675000000000002</c:v>
                </c:pt>
                <c:pt idx="24">
                  <c:v>0.24725000000000003</c:v>
                </c:pt>
                <c:pt idx="25">
                  <c:v>0.24925000000000003</c:v>
                </c:pt>
              </c:numCache>
            </c:numRef>
          </c:val>
        </c:ser>
        <c:ser>
          <c:idx val="1"/>
          <c:order val="1"/>
          <c:tx>
            <c:v>endophyte</c:v>
          </c:tx>
          <c:spPr>
            <a:ln>
              <a:solidFill>
                <a:schemeClr val="tx1"/>
              </a:solidFill>
            </a:ln>
          </c:spPr>
          <c:marker>
            <c:spPr>
              <a:solidFill>
                <a:schemeClr val="tx1"/>
              </a:solidFill>
            </c:spPr>
          </c:marker>
          <c:val>
            <c:numRef>
              <c:f>PSII!$Y$59:$Y$84</c:f>
              <c:numCache>
                <c:formatCode>General</c:formatCode>
                <c:ptCount val="26"/>
                <c:pt idx="0">
                  <c:v>0.19033333333333338</c:v>
                </c:pt>
                <c:pt idx="1">
                  <c:v>0.25444444444444447</c:v>
                </c:pt>
                <c:pt idx="2">
                  <c:v>0.89966666666666673</c:v>
                </c:pt>
                <c:pt idx="3">
                  <c:v>0.47122222222222226</c:v>
                </c:pt>
                <c:pt idx="4">
                  <c:v>0.37888888888888905</c:v>
                </c:pt>
                <c:pt idx="5">
                  <c:v>0.34466666666666673</c:v>
                </c:pt>
                <c:pt idx="6">
                  <c:v>0.31800000000000006</c:v>
                </c:pt>
                <c:pt idx="7">
                  <c:v>0.29444444444444456</c:v>
                </c:pt>
                <c:pt idx="8">
                  <c:v>0.27666666666666673</c:v>
                </c:pt>
                <c:pt idx="9">
                  <c:v>0.26511111111111113</c:v>
                </c:pt>
                <c:pt idx="10">
                  <c:v>0.2553333333333333</c:v>
                </c:pt>
                <c:pt idx="11">
                  <c:v>0.24677777777777779</c:v>
                </c:pt>
                <c:pt idx="12">
                  <c:v>0.2406666666666667</c:v>
                </c:pt>
                <c:pt idx="13">
                  <c:v>0.23644444444444451</c:v>
                </c:pt>
                <c:pt idx="14">
                  <c:v>0.23244444444444451</c:v>
                </c:pt>
                <c:pt idx="15">
                  <c:v>0.23100000000000001</c:v>
                </c:pt>
                <c:pt idx="16">
                  <c:v>0.22922222222222224</c:v>
                </c:pt>
                <c:pt idx="17">
                  <c:v>0.22722222222222221</c:v>
                </c:pt>
                <c:pt idx="18">
                  <c:v>0.22555555555555556</c:v>
                </c:pt>
                <c:pt idx="19">
                  <c:v>0.224</c:v>
                </c:pt>
                <c:pt idx="20">
                  <c:v>0.22311111111111115</c:v>
                </c:pt>
                <c:pt idx="21">
                  <c:v>0.22188888888888889</c:v>
                </c:pt>
                <c:pt idx="22">
                  <c:v>0.22122222222222221</c:v>
                </c:pt>
                <c:pt idx="23">
                  <c:v>0.22155555555555553</c:v>
                </c:pt>
                <c:pt idx="24">
                  <c:v>0.22044444444444447</c:v>
                </c:pt>
                <c:pt idx="25">
                  <c:v>0.21955555555555556</c:v>
                </c:pt>
              </c:numCache>
            </c:numRef>
          </c:val>
        </c:ser>
        <c:dLbls/>
        <c:marker val="1"/>
        <c:axId val="58888576"/>
        <c:axId val="58890496"/>
      </c:lineChart>
      <c:catAx>
        <c:axId val="58888576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pulse</a:t>
                </a:r>
              </a:p>
            </c:rich>
          </c:tx>
          <c:layout/>
        </c:title>
        <c:numFmt formatCode="General" sourceLinked="1"/>
        <c:tickLblPos val="nextTo"/>
        <c:crossAx val="58890496"/>
        <c:crosses val="autoZero"/>
        <c:auto val="1"/>
        <c:lblAlgn val="ctr"/>
        <c:lblOffset val="100"/>
      </c:catAx>
      <c:valAx>
        <c:axId val="58890496"/>
        <c:scaling>
          <c:orientation val="minMax"/>
        </c:scaling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Y(NO)</a:t>
                </a:r>
              </a:p>
            </c:rich>
          </c:tx>
          <c:layout/>
        </c:title>
        <c:numFmt formatCode="General" sourceLinked="1"/>
        <c:tickLblPos val="nextTo"/>
        <c:crossAx val="58888576"/>
        <c:crosses val="autoZero"/>
        <c:crossBetween val="between"/>
      </c:valAx>
    </c:plotArea>
    <c:plotVisOnly val="1"/>
    <c:dispBlanksAs val="gap"/>
  </c:chart>
  <c:externalData r:id="rId1"/>
  <c:userShapes r:id="rId2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pl-PL"/>
  <c:chart>
    <c:plotArea>
      <c:layout>
        <c:manualLayout>
          <c:layoutTarget val="inner"/>
          <c:xMode val="edge"/>
          <c:yMode val="edge"/>
          <c:x val="0.12652373737373737"/>
          <c:y val="5.1400554097404488E-2"/>
          <c:w val="0.85440479797979818"/>
          <c:h val="0.78169364246135908"/>
        </c:manualLayout>
      </c:layout>
      <c:lineChart>
        <c:grouping val="standard"/>
        <c:ser>
          <c:idx val="0"/>
          <c:order val="0"/>
          <c:tx>
            <c:v>control</c:v>
          </c:tx>
          <c:spPr>
            <a:ln>
              <a:solidFill>
                <a:schemeClr val="bg1">
                  <a:lumMod val="65000"/>
                </a:schemeClr>
              </a:solidFill>
            </a:ln>
          </c:spPr>
          <c:marker>
            <c:spPr>
              <a:solidFill>
                <a:schemeClr val="bg1">
                  <a:lumMod val="65000"/>
                </a:schemeClr>
              </a:solidFill>
            </c:spPr>
          </c:marker>
          <c:val>
            <c:numRef>
              <c:f>PSII!$K$87:$K$112</c:f>
              <c:numCache>
                <c:formatCode>General</c:formatCode>
                <c:ptCount val="26"/>
                <c:pt idx="0">
                  <c:v>0</c:v>
                </c:pt>
                <c:pt idx="1">
                  <c:v>6.1249999999999985E-3</c:v>
                </c:pt>
                <c:pt idx="2">
                  <c:v>1.4624999999999999E-2</c:v>
                </c:pt>
                <c:pt idx="3">
                  <c:v>0.33637500000000015</c:v>
                </c:pt>
                <c:pt idx="4">
                  <c:v>0.43350000000000005</c:v>
                </c:pt>
                <c:pt idx="5">
                  <c:v>0.45375000000000004</c:v>
                </c:pt>
                <c:pt idx="6">
                  <c:v>0.44712500000000011</c:v>
                </c:pt>
                <c:pt idx="7">
                  <c:v>0.42687500000000006</c:v>
                </c:pt>
                <c:pt idx="8">
                  <c:v>0.40512500000000001</c:v>
                </c:pt>
                <c:pt idx="9">
                  <c:v>0.38712500000000005</c:v>
                </c:pt>
                <c:pt idx="10">
                  <c:v>0.37487500000000007</c:v>
                </c:pt>
                <c:pt idx="11">
                  <c:v>0.36687500000000006</c:v>
                </c:pt>
                <c:pt idx="12">
                  <c:v>0.36025000000000001</c:v>
                </c:pt>
                <c:pt idx="13">
                  <c:v>0.35337500000000016</c:v>
                </c:pt>
                <c:pt idx="14">
                  <c:v>0.3468750000000001</c:v>
                </c:pt>
                <c:pt idx="15">
                  <c:v>0.33987500000000015</c:v>
                </c:pt>
                <c:pt idx="16">
                  <c:v>0.33437500000000014</c:v>
                </c:pt>
                <c:pt idx="17">
                  <c:v>0.32787500000000014</c:v>
                </c:pt>
                <c:pt idx="18">
                  <c:v>0.32350000000000007</c:v>
                </c:pt>
                <c:pt idx="19">
                  <c:v>0.3186250000000001</c:v>
                </c:pt>
                <c:pt idx="20">
                  <c:v>0.31375000000000008</c:v>
                </c:pt>
                <c:pt idx="21">
                  <c:v>0.30962500000000009</c:v>
                </c:pt>
                <c:pt idx="22">
                  <c:v>0.30525000000000002</c:v>
                </c:pt>
                <c:pt idx="23">
                  <c:v>0.30012500000000009</c:v>
                </c:pt>
                <c:pt idx="24">
                  <c:v>0.29500000000000004</c:v>
                </c:pt>
                <c:pt idx="25">
                  <c:v>0.29075000000000001</c:v>
                </c:pt>
              </c:numCache>
            </c:numRef>
          </c:val>
        </c:ser>
        <c:ser>
          <c:idx val="1"/>
          <c:order val="1"/>
          <c:tx>
            <c:v>endophyte</c:v>
          </c:tx>
          <c:spPr>
            <a:ln>
              <a:solidFill>
                <a:schemeClr val="tx1"/>
              </a:solidFill>
            </a:ln>
          </c:spPr>
          <c:marker>
            <c:spPr>
              <a:solidFill>
                <a:schemeClr val="tx1"/>
              </a:solidFill>
            </c:spPr>
          </c:marker>
          <c:val>
            <c:numRef>
              <c:f>PSII!$Y$87:$Y$112</c:f>
              <c:numCache>
                <c:formatCode>General</c:formatCode>
                <c:ptCount val="26"/>
                <c:pt idx="0">
                  <c:v>0</c:v>
                </c:pt>
                <c:pt idx="1">
                  <c:v>8.8888888888888924E-3</c:v>
                </c:pt>
                <c:pt idx="2">
                  <c:v>1.3444444444444445E-2</c:v>
                </c:pt>
                <c:pt idx="3">
                  <c:v>0.22622222222222221</c:v>
                </c:pt>
                <c:pt idx="4">
                  <c:v>0.2956666666666668</c:v>
                </c:pt>
                <c:pt idx="5">
                  <c:v>0.31855555555555548</c:v>
                </c:pt>
                <c:pt idx="6">
                  <c:v>0.32944444444444443</c:v>
                </c:pt>
                <c:pt idx="7">
                  <c:v>0.33322222222222231</c:v>
                </c:pt>
                <c:pt idx="8">
                  <c:v>0.33177777777777789</c:v>
                </c:pt>
                <c:pt idx="9">
                  <c:v>0.32966666666666677</c:v>
                </c:pt>
                <c:pt idx="10">
                  <c:v>0.32844444444444454</c:v>
                </c:pt>
                <c:pt idx="11">
                  <c:v>0.32788888888888906</c:v>
                </c:pt>
                <c:pt idx="12">
                  <c:v>0.32655555555555554</c:v>
                </c:pt>
                <c:pt idx="13">
                  <c:v>0.3252222222222223</c:v>
                </c:pt>
                <c:pt idx="14">
                  <c:v>0.32166666666666677</c:v>
                </c:pt>
                <c:pt idx="15">
                  <c:v>0.31900000000000006</c:v>
                </c:pt>
                <c:pt idx="16">
                  <c:v>0.31611111111111112</c:v>
                </c:pt>
                <c:pt idx="17">
                  <c:v>0.31344444444444453</c:v>
                </c:pt>
                <c:pt idx="18">
                  <c:v>0.31088888888888899</c:v>
                </c:pt>
                <c:pt idx="19">
                  <c:v>0.30844444444444447</c:v>
                </c:pt>
                <c:pt idx="20">
                  <c:v>0.30600000000000011</c:v>
                </c:pt>
                <c:pt idx="21">
                  <c:v>0.30322222222222223</c:v>
                </c:pt>
                <c:pt idx="22">
                  <c:v>0.30144444444444451</c:v>
                </c:pt>
                <c:pt idx="23">
                  <c:v>0.29988888888888898</c:v>
                </c:pt>
                <c:pt idx="24">
                  <c:v>0.2980000000000001</c:v>
                </c:pt>
                <c:pt idx="25">
                  <c:v>0.29633333333333334</c:v>
                </c:pt>
              </c:numCache>
            </c:numRef>
          </c:val>
        </c:ser>
        <c:dLbls/>
        <c:marker val="1"/>
        <c:axId val="58944128"/>
        <c:axId val="58958976"/>
      </c:lineChart>
      <c:catAx>
        <c:axId val="58944128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pulse</a:t>
                </a:r>
              </a:p>
            </c:rich>
          </c:tx>
          <c:layout/>
        </c:title>
        <c:numFmt formatCode="General" sourceLinked="1"/>
        <c:tickLblPos val="nextTo"/>
        <c:crossAx val="58958976"/>
        <c:crosses val="autoZero"/>
        <c:auto val="1"/>
        <c:lblAlgn val="ctr"/>
        <c:lblOffset val="100"/>
      </c:catAx>
      <c:valAx>
        <c:axId val="58958976"/>
        <c:scaling>
          <c:orientation val="minMax"/>
        </c:scaling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Y(NPQ)</a:t>
                </a:r>
              </a:p>
            </c:rich>
          </c:tx>
          <c:layout/>
        </c:title>
        <c:numFmt formatCode="General" sourceLinked="1"/>
        <c:tickLblPos val="nextTo"/>
        <c:crossAx val="5894412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6866103535353536"/>
          <c:y val="0.53855138888888898"/>
          <c:w val="0.26361691919191926"/>
          <c:h val="0.2085916666666667"/>
        </c:manualLayout>
      </c:layout>
    </c:legend>
    <c:plotVisOnly val="1"/>
    <c:dispBlanksAs val="gap"/>
  </c:chart>
  <c:externalData r:id="rId1"/>
  <c:userShapes r:id="rId2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pl-PL"/>
  <c:chart>
    <c:autoTitleDeleted val="1"/>
    <c:plotArea>
      <c:layout/>
      <c:barChart>
        <c:barDir val="col"/>
        <c:grouping val="clustered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dPt>
            <c:idx val="0"/>
            <c:spPr>
              <a:solidFill>
                <a:schemeClr val="bg1">
                  <a:lumMod val="65000"/>
                </a:schemeClr>
              </a:solidFill>
              <a:ln>
                <a:noFill/>
              </a:ln>
              <a:effectLst/>
            </c:spPr>
          </c:dPt>
          <c:dPt>
            <c:idx val="1"/>
            <c:spPr>
              <a:solidFill>
                <a:schemeClr val="tx1"/>
              </a:solidFill>
              <a:ln>
                <a:noFill/>
              </a:ln>
              <a:effectLst/>
            </c:spPr>
          </c:dPt>
          <c:cat>
            <c:strRef>
              <c:f>PSII!$AJ$12:$AJ$13</c:f>
              <c:strCache>
                <c:ptCount val="2"/>
                <c:pt idx="0">
                  <c:v>control</c:v>
                </c:pt>
                <c:pt idx="1">
                  <c:v>endophyte</c:v>
                </c:pt>
              </c:strCache>
            </c:strRef>
          </c:cat>
          <c:val>
            <c:numRef>
              <c:f>(PSII!$K$3,PSII!$Y$3)</c:f>
              <c:numCache>
                <c:formatCode>General</c:formatCode>
                <c:ptCount val="2"/>
                <c:pt idx="0">
                  <c:v>0.80137500000000017</c:v>
                </c:pt>
                <c:pt idx="1">
                  <c:v>0.81022222222222229</c:v>
                </c:pt>
              </c:numCache>
            </c:numRef>
          </c:val>
        </c:ser>
        <c:dLbls/>
        <c:gapWidth val="219"/>
        <c:overlap val="-27"/>
        <c:axId val="46443904"/>
        <c:axId val="46449408"/>
      </c:barChart>
      <c:catAx>
        <c:axId val="46443904"/>
        <c:scaling>
          <c:orientation val="minMax"/>
        </c:scaling>
        <c:axPos val="b"/>
        <c:numFmt formatCode="General" sourceLinked="1"/>
        <c:majorTickMark val="none"/>
        <c:tickLblPos val="nextTo"/>
        <c:spPr>
          <a:noFill/>
          <a:ln w="9525" cap="flat" cmpd="sng" algn="ctr">
            <a:solidFill>
              <a:schemeClr val="bg1">
                <a:lumMod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pl-PL"/>
          </a:p>
        </c:txPr>
        <c:crossAx val="46449408"/>
        <c:crosses val="autoZero"/>
        <c:auto val="1"/>
        <c:lblAlgn val="ctr"/>
        <c:lblOffset val="100"/>
      </c:catAx>
      <c:valAx>
        <c:axId val="46449408"/>
        <c:scaling>
          <c:orientation val="minMax"/>
          <c:min val="0"/>
        </c:scaling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aseline="0">
                    <a:solidFill>
                      <a:sysClr val="windowText" lastClr="000000"/>
                    </a:solidFill>
                  </a:rPr>
                  <a:t>Fv/Fm</a:t>
                </a:r>
              </a:p>
            </c:rich>
          </c:tx>
          <c:layout/>
          <c:spPr>
            <a:noFill/>
            <a:ln>
              <a:noFill/>
            </a:ln>
            <a:effectLst/>
          </c:spPr>
        </c:title>
        <c:numFmt formatCode="General" sourceLinked="1"/>
        <c:tickLblPos val="nextTo"/>
        <c:spPr>
          <a:noFill/>
          <a:ln>
            <a:solidFill>
              <a:schemeClr val="bg1">
                <a:lumMod val="5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pl-PL"/>
          </a:p>
        </c:txPr>
        <c:crossAx val="4644390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</c:chart>
  <c:spPr>
    <a:noFill/>
    <a:ln>
      <a:noFill/>
    </a:ln>
    <a:effectLst/>
  </c:spPr>
  <c:txPr>
    <a:bodyPr/>
    <a:lstStyle/>
    <a:p>
      <a:pPr>
        <a:defRPr/>
      </a:pPr>
      <a:endParaRPr lang="pl-PL"/>
    </a:p>
  </c:txPr>
  <c:externalData r:id="rId1"/>
  <c:userShapes r:id="rId2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86536</cdr:x>
      <cdr:y>0.53457</cdr:y>
    </cdr:from>
    <cdr:to>
      <cdr:x>0.94437</cdr:x>
      <cdr:y>0.70556</cdr:y>
    </cdr:to>
    <cdr:sp macro="" textlink="">
      <cdr:nvSpPr>
        <cdr:cNvPr id="2" name="pole tekstowe 8"/>
        <cdr:cNvSpPr txBox="1"/>
      </cdr:nvSpPr>
      <cdr:spPr>
        <a:xfrm xmlns:a="http://schemas.openxmlformats.org/drawingml/2006/main">
          <a:off x="3426810" y="1154671"/>
          <a:ext cx="312906" cy="36933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pl-PL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pl-PL" dirty="0" smtClean="0">
              <a:latin typeface="Arial" panose="020B0604020202020204" pitchFamily="34" charset="0"/>
              <a:cs typeface="Arial" panose="020B0604020202020204" pitchFamily="34" charset="0"/>
            </a:rPr>
            <a:t>b</a:t>
          </a:r>
          <a:endParaRPr lang="pl-PL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88723</cdr:x>
      <cdr:y>0.10361</cdr:y>
    </cdr:from>
    <cdr:to>
      <cdr:x>0.96301</cdr:x>
      <cdr:y>0.2746</cdr:y>
    </cdr:to>
    <cdr:sp macro="" textlink="">
      <cdr:nvSpPr>
        <cdr:cNvPr id="2" name="pole tekstowe 8"/>
        <cdr:cNvSpPr txBox="1"/>
      </cdr:nvSpPr>
      <cdr:spPr>
        <a:xfrm xmlns:a="http://schemas.openxmlformats.org/drawingml/2006/main">
          <a:off x="3513438" y="223795"/>
          <a:ext cx="300082" cy="36933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pl-PL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pl-PL" dirty="0" smtClean="0">
              <a:latin typeface="Arial" panose="020B0604020202020204" pitchFamily="34" charset="0"/>
              <a:cs typeface="Arial" panose="020B0604020202020204" pitchFamily="34" charset="0"/>
            </a:rPr>
            <a:t>c</a:t>
          </a:r>
          <a:endParaRPr lang="pl-PL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9189</cdr:x>
      <cdr:y>0.00858</cdr:y>
    </cdr:from>
    <cdr:to>
      <cdr:x>0.99792</cdr:x>
      <cdr:y>0.17957</cdr:y>
    </cdr:to>
    <cdr:sp macro="" textlink="">
      <cdr:nvSpPr>
        <cdr:cNvPr id="2" name="pole tekstowe 8"/>
        <cdr:cNvSpPr txBox="1"/>
      </cdr:nvSpPr>
      <cdr:spPr>
        <a:xfrm xmlns:a="http://schemas.openxmlformats.org/drawingml/2006/main">
          <a:off x="3638856" y="18536"/>
          <a:ext cx="312906" cy="36933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pl-PL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pl-PL" dirty="0" smtClean="0">
              <a:latin typeface="Arial" panose="020B0604020202020204" pitchFamily="34" charset="0"/>
              <a:cs typeface="Arial" panose="020B0604020202020204" pitchFamily="34" charset="0"/>
            </a:rPr>
            <a:t>d</a:t>
          </a:r>
          <a:endParaRPr lang="pl-PL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4.xml><?xml version="1.0" encoding="utf-8"?>
<c:userShapes xmlns:c="http://schemas.openxmlformats.org/drawingml/2006/chart">
  <cdr:relSizeAnchor xmlns:cdr="http://schemas.openxmlformats.org/drawingml/2006/chartDrawing">
    <cdr:from>
      <cdr:x>0.85976</cdr:x>
      <cdr:y>0</cdr:y>
    </cdr:from>
    <cdr:to>
      <cdr:x>0.9282</cdr:x>
      <cdr:y>0.13464</cdr:y>
    </cdr:to>
    <cdr:sp macro="" textlink="">
      <cdr:nvSpPr>
        <cdr:cNvPr id="2" name="pole tekstowe 8"/>
        <cdr:cNvSpPr txBox="1"/>
      </cdr:nvSpPr>
      <cdr:spPr>
        <a:xfrm xmlns:a="http://schemas.openxmlformats.org/drawingml/2006/main">
          <a:off x="3930822" y="-2807044"/>
          <a:ext cx="312906" cy="36933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pl-PL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pl-PL" dirty="0" smtClean="0">
              <a:latin typeface="Arial" panose="020B0604020202020204" pitchFamily="34" charset="0"/>
              <a:cs typeface="Arial" panose="020B0604020202020204" pitchFamily="34" charset="0"/>
            </a:rPr>
            <a:t>e</a:t>
          </a:r>
          <a:endParaRPr lang="pl-PL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Podtytuł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l-PL" smtClean="0"/>
              <a:t>Kliknij, aby edytować styl wzorca podtytułu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4B82E-0B9C-443D-8833-3C53A7056C22}" type="datetimeFigureOut">
              <a:rPr lang="pl-PL" smtClean="0"/>
              <a:pPr/>
              <a:t>2015-04-09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0FBB39-8B81-4926-B8F8-74B41F0BF98F}" type="slidenum">
              <a:rPr lang="pl-PL" smtClean="0"/>
              <a:pPr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xmlns="" val="15734833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4B82E-0B9C-443D-8833-3C53A7056C22}" type="datetimeFigureOut">
              <a:rPr lang="pl-PL" smtClean="0"/>
              <a:pPr/>
              <a:t>2015-04-09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0FBB39-8B81-4926-B8F8-74B41F0BF98F}" type="slidenum">
              <a:rPr lang="pl-PL" smtClean="0"/>
              <a:pPr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xmlns="" val="26469330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pionowy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4B82E-0B9C-443D-8833-3C53A7056C22}" type="datetimeFigureOut">
              <a:rPr lang="pl-PL" smtClean="0"/>
              <a:pPr/>
              <a:t>2015-04-09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0FBB39-8B81-4926-B8F8-74B41F0BF98F}" type="slidenum">
              <a:rPr lang="pl-PL" smtClean="0"/>
              <a:pPr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xmlns="" val="30583171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4B82E-0B9C-443D-8833-3C53A7056C22}" type="datetimeFigureOut">
              <a:rPr lang="pl-PL" smtClean="0"/>
              <a:pPr/>
              <a:t>2015-04-09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0FBB39-8B81-4926-B8F8-74B41F0BF98F}" type="slidenum">
              <a:rPr lang="pl-PL" smtClean="0"/>
              <a:pPr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xmlns="" val="30381142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4B82E-0B9C-443D-8833-3C53A7056C22}" type="datetimeFigureOut">
              <a:rPr lang="pl-PL" smtClean="0"/>
              <a:pPr/>
              <a:t>2015-04-09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0FBB39-8B81-4926-B8F8-74B41F0BF98F}" type="slidenum">
              <a:rPr lang="pl-PL" smtClean="0"/>
              <a:pPr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xmlns="" val="36040437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4B82E-0B9C-443D-8833-3C53A7056C22}" type="datetimeFigureOut">
              <a:rPr lang="pl-PL" smtClean="0"/>
              <a:pPr/>
              <a:t>2015-04-09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0FBB39-8B81-4926-B8F8-74B41F0BF98F}" type="slidenum">
              <a:rPr lang="pl-PL" smtClean="0"/>
              <a:pPr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xmlns="" val="33992277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5" name="Symbol zastępczy tekstu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6" name="Symbol zastępczy zawartości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7" name="Symbol zastępczy daty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4B82E-0B9C-443D-8833-3C53A7056C22}" type="datetimeFigureOut">
              <a:rPr lang="pl-PL" smtClean="0"/>
              <a:pPr/>
              <a:t>2015-04-09</a:t>
            </a:fld>
            <a:endParaRPr lang="pl-PL"/>
          </a:p>
        </p:txBody>
      </p:sp>
      <p:sp>
        <p:nvSpPr>
          <p:cNvPr id="8" name="Symbol zastępczy stopki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9" name="Symbol zastępczy numeru slajdu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0FBB39-8B81-4926-B8F8-74B41F0BF98F}" type="slidenum">
              <a:rPr lang="pl-PL" smtClean="0"/>
              <a:pPr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xmlns="" val="34939430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daty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4B82E-0B9C-443D-8833-3C53A7056C22}" type="datetimeFigureOut">
              <a:rPr lang="pl-PL" smtClean="0"/>
              <a:pPr/>
              <a:t>2015-04-09</a:t>
            </a:fld>
            <a:endParaRPr lang="pl-PL"/>
          </a:p>
        </p:txBody>
      </p:sp>
      <p:sp>
        <p:nvSpPr>
          <p:cNvPr id="4" name="Symbol zastępczy stopki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5" name="Symbol zastępczy numeru slajdu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0FBB39-8B81-4926-B8F8-74B41F0BF98F}" type="slidenum">
              <a:rPr lang="pl-PL" smtClean="0"/>
              <a:pPr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xmlns="" val="14904538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daty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4B82E-0B9C-443D-8833-3C53A7056C22}" type="datetimeFigureOut">
              <a:rPr lang="pl-PL" smtClean="0"/>
              <a:pPr/>
              <a:t>2015-04-09</a:t>
            </a:fld>
            <a:endParaRPr lang="pl-PL"/>
          </a:p>
        </p:txBody>
      </p:sp>
      <p:sp>
        <p:nvSpPr>
          <p:cNvPr id="3" name="Symbol zastępczy stopki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4" name="Symbol zastępczy numeru slajdu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0FBB39-8B81-4926-B8F8-74B41F0BF98F}" type="slidenum">
              <a:rPr lang="pl-PL" smtClean="0"/>
              <a:pPr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xmlns="" val="28407895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4B82E-0B9C-443D-8833-3C53A7056C22}" type="datetimeFigureOut">
              <a:rPr lang="pl-PL" smtClean="0"/>
              <a:pPr/>
              <a:t>2015-04-09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0FBB39-8B81-4926-B8F8-74B41F0BF98F}" type="slidenum">
              <a:rPr lang="pl-PL" smtClean="0"/>
              <a:pPr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xmlns="" val="23493671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obrazu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l-PL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4B82E-0B9C-443D-8833-3C53A7056C22}" type="datetimeFigureOut">
              <a:rPr lang="pl-PL" smtClean="0"/>
              <a:pPr/>
              <a:t>2015-04-09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0FBB39-8B81-4926-B8F8-74B41F0BF98F}" type="slidenum">
              <a:rPr lang="pl-PL" smtClean="0"/>
              <a:pPr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xmlns="" val="33477398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tytułu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54B82E-0B9C-443D-8833-3C53A7056C22}" type="datetimeFigureOut">
              <a:rPr lang="pl-PL" smtClean="0"/>
              <a:pPr/>
              <a:t>2015-04-09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0FBB39-8B81-4926-B8F8-74B41F0BF98F}" type="slidenum">
              <a:rPr lang="pl-PL" smtClean="0"/>
              <a:pPr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xmlns="" val="25422927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l-P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Wykres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3036442179"/>
              </p:ext>
            </p:extLst>
          </p:nvPr>
        </p:nvGraphicFramePr>
        <p:xfrm>
          <a:off x="111211" y="220362"/>
          <a:ext cx="3960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Wykres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1224101129"/>
              </p:ext>
            </p:extLst>
          </p:nvPr>
        </p:nvGraphicFramePr>
        <p:xfrm>
          <a:off x="288324" y="2333368"/>
          <a:ext cx="3960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Wykres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1628802326"/>
              </p:ext>
            </p:extLst>
          </p:nvPr>
        </p:nvGraphicFramePr>
        <p:xfrm>
          <a:off x="210065" y="4413422"/>
          <a:ext cx="3960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" name="Wykres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3882099122"/>
              </p:ext>
            </p:extLst>
          </p:nvPr>
        </p:nvGraphicFramePr>
        <p:xfrm>
          <a:off x="5416378" y="154459"/>
          <a:ext cx="3960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8" name="Wykres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4250413846"/>
              </p:ext>
            </p:extLst>
          </p:nvPr>
        </p:nvGraphicFramePr>
        <p:xfrm>
          <a:off x="5292811" y="2807044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9" name="pole tekstowe 8"/>
          <p:cNvSpPr txBox="1"/>
          <p:nvPr/>
        </p:nvSpPr>
        <p:spPr>
          <a:xfrm>
            <a:off x="3723503" y="172995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pl-PL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pole tekstowe 9"/>
          <p:cNvSpPr txBox="1"/>
          <p:nvPr/>
        </p:nvSpPr>
        <p:spPr>
          <a:xfrm>
            <a:off x="8134479" y="6211669"/>
            <a:ext cx="405752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pl-PL" dirty="0" smtClean="0">
                <a:latin typeface="Arial" panose="020B0604020202020204" pitchFamily="34" charset="0"/>
                <a:cs typeface="Arial" panose="020B0604020202020204" pitchFamily="34" charset="0"/>
              </a:rPr>
              <a:t> Fig. 1 </a:t>
            </a:r>
          </a:p>
          <a:p>
            <a:r>
              <a:rPr lang="pl-PL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sults</a:t>
            </a:r>
            <a:r>
              <a:rPr lang="pl-PL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l-PL" dirty="0" smtClean="0">
                <a:latin typeface="Arial" panose="020B0604020202020204" pitchFamily="34" charset="0"/>
                <a:cs typeface="Arial" panose="020B0604020202020204" pitchFamily="34" charset="0"/>
              </a:rPr>
              <a:t>from </a:t>
            </a:r>
            <a:r>
              <a:rPr lang="pl-PL" dirty="0" err="1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pl-PL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duction</a:t>
            </a:r>
            <a:r>
              <a:rPr lang="pl-PL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l-PL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urve</a:t>
            </a:r>
            <a:r>
              <a:rPr lang="pl-PL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l-PL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alysis</a:t>
            </a:r>
            <a:r>
              <a:rPr lang="pl-PL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pl-PL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498106582"/>
      </p:ext>
    </p:extLst>
  </p:cSld>
  <p:clrMapOvr>
    <a:masterClrMapping/>
  </p:clrMapOvr>
</p:sld>
</file>

<file path=ppt/theme/theme1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Pakiet 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26</Words>
  <Application>Microsoft Office PowerPoint</Application>
  <PresentationFormat>Niestandardowy</PresentationFormat>
  <Paragraphs>16</Paragraphs>
  <Slides>1</Slides>
  <Notes>0</Notes>
  <HiddenSlides>0</HiddenSlides>
  <MMClips>0</MMClips>
  <ScaleCrop>false</ScaleCrop>
  <HeadingPairs>
    <vt:vector size="4" baseType="variant">
      <vt:variant>
        <vt:lpstr>Motyw</vt:lpstr>
      </vt:variant>
      <vt:variant>
        <vt:i4>1</vt:i4>
      </vt:variant>
      <vt:variant>
        <vt:lpstr>Tytuły slajdów</vt:lpstr>
      </vt:variant>
      <vt:variant>
        <vt:i4>1</vt:i4>
      </vt:variant>
    </vt:vector>
  </HeadingPairs>
  <TitlesOfParts>
    <vt:vector size="2" baseType="lpstr">
      <vt:lpstr>Motyw pakietu Office</vt:lpstr>
      <vt:lpstr>Slajd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ja programu PowerPoint</dc:title>
  <dc:creator>MCB_USER</dc:creator>
  <cp:lastModifiedBy>Michał Nosek</cp:lastModifiedBy>
  <cp:revision>4</cp:revision>
  <dcterms:created xsi:type="dcterms:W3CDTF">2015-04-08T06:56:05Z</dcterms:created>
  <dcterms:modified xsi:type="dcterms:W3CDTF">2015-04-09T13:39:52Z</dcterms:modified>
</cp:coreProperties>
</file>